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840" r:id="rId1"/>
  </p:sldMasterIdLst>
  <p:notesMasterIdLst>
    <p:notesMasterId r:id="rId15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8" r:id="rId11"/>
    <p:sldId id="265" r:id="rId12"/>
    <p:sldId id="266" r:id="rId13"/>
    <p:sldId id="267" r:id="rId14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287"/>
    <p:restoredTop sz="93399"/>
  </p:normalViewPr>
  <p:slideViewPr>
    <p:cSldViewPr snapToGrid="0" snapToObjects="1">
      <p:cViewPr varScale="1">
        <p:scale>
          <a:sx n="96" d="100"/>
          <a:sy n="96" d="100"/>
        </p:scale>
        <p:origin x="459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160A57-A7C6-034B-B03A-115C5C43AFFB}" type="datetimeFigureOut">
              <a:rPr lang="en-US" smtClean="0"/>
              <a:t>6/28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A08B30-0097-7446-83BB-7902F7F332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6599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9A08B30-0097-7446-83BB-7902F7F332E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01851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9A08B30-0097-7446-83BB-7902F7F332EC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00380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9A08B30-0097-7446-83BB-7902F7F332EC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8977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CE055-66DE-C041-B08A-D14616D9E3BF}" type="datetimeFigureOut">
              <a:rPr lang="en-US" smtClean="0"/>
              <a:t>6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7AF8-9982-4441-8506-637EB25D04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7687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CE055-66DE-C041-B08A-D14616D9E3BF}" type="datetimeFigureOut">
              <a:rPr lang="en-US" smtClean="0"/>
              <a:t>6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7AF8-9982-4441-8506-637EB25D04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3769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CE055-66DE-C041-B08A-D14616D9E3BF}" type="datetimeFigureOut">
              <a:rPr lang="en-US" smtClean="0"/>
              <a:t>6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7AF8-9982-4441-8506-637EB25D04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57323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CE055-66DE-C041-B08A-D14616D9E3BF}" type="datetimeFigureOut">
              <a:rPr lang="en-US" smtClean="0"/>
              <a:t>6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7AF8-9982-4441-8506-637EB25D04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0307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CE055-66DE-C041-B08A-D14616D9E3BF}" type="datetimeFigureOut">
              <a:rPr lang="en-US" smtClean="0"/>
              <a:t>6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7AF8-9982-4441-8506-637EB25D04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43201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CE055-66DE-C041-B08A-D14616D9E3BF}" type="datetimeFigureOut">
              <a:rPr lang="en-US" smtClean="0"/>
              <a:t>6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7AF8-9982-4441-8506-637EB25D04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589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CE055-66DE-C041-B08A-D14616D9E3BF}" type="datetimeFigureOut">
              <a:rPr lang="en-US" smtClean="0"/>
              <a:t>6/28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7AF8-9982-4441-8506-637EB25D04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4541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CE055-66DE-C041-B08A-D14616D9E3BF}" type="datetimeFigureOut">
              <a:rPr lang="en-US" smtClean="0"/>
              <a:t>6/28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7AF8-9982-4441-8506-637EB25D04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5871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CE055-66DE-C041-B08A-D14616D9E3BF}" type="datetimeFigureOut">
              <a:rPr lang="en-US" smtClean="0"/>
              <a:t>6/28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7AF8-9982-4441-8506-637EB25D04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62372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CE055-66DE-C041-B08A-D14616D9E3BF}" type="datetimeFigureOut">
              <a:rPr lang="en-US" smtClean="0"/>
              <a:t>6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7AF8-9982-4441-8506-637EB25D04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4063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7CE055-66DE-C041-B08A-D14616D9E3BF}" type="datetimeFigureOut">
              <a:rPr lang="en-US" smtClean="0"/>
              <a:t>6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F7AF8-9982-4441-8506-637EB25D04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19904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7CE055-66DE-C041-B08A-D14616D9E3BF}" type="datetimeFigureOut">
              <a:rPr lang="en-US" smtClean="0"/>
              <a:t>6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DF7AF8-9982-4441-8506-637EB25D04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6325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41" r:id="rId1"/>
    <p:sldLayoutId id="2147483842" r:id="rId2"/>
    <p:sldLayoutId id="2147483843" r:id="rId3"/>
    <p:sldLayoutId id="2147483844" r:id="rId4"/>
    <p:sldLayoutId id="2147483845" r:id="rId5"/>
    <p:sldLayoutId id="2147483846" r:id="rId6"/>
    <p:sldLayoutId id="2147483847" r:id="rId7"/>
    <p:sldLayoutId id="2147483848" r:id="rId8"/>
    <p:sldLayoutId id="2147483849" r:id="rId9"/>
    <p:sldLayoutId id="2147483850" r:id="rId10"/>
    <p:sldLayoutId id="214748385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/><Relationship Id="rId3" Type="http://schemas.openxmlformats.org/officeDocument/2006/relationships/image" Target="../media/image12.png"/><Relationship Id="rId7" Type="http://schemas.openxmlformats.org/officeDocument/2006/relationships/image" Target="../media/image15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emf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A090729-3634-CC18-4EB9-0CAEF6A7B96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0"/>
            <a:ext cx="7559675" cy="907161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171BF5E-CF5C-88FF-8EF4-143545C4A281}"/>
              </a:ext>
            </a:extLst>
          </p:cNvPr>
          <p:cNvSpPr txBox="1"/>
          <p:nvPr/>
        </p:nvSpPr>
        <p:spPr>
          <a:xfrm>
            <a:off x="0" y="8937487"/>
            <a:ext cx="7559675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 defTabSz="914400">
              <a:defRPr/>
            </a:pPr>
            <a:r>
              <a:rPr lang="en-US" dirty="0"/>
              <a:t>Supplementary Figure S1: Annotation enrichment weights estimated by </a:t>
            </a:r>
            <a:r>
              <a:rPr lang="en-US" dirty="0" err="1"/>
              <a:t>SparsePro</a:t>
            </a:r>
            <a:r>
              <a:rPr lang="en-US" dirty="0"/>
              <a:t> in locus simulations. Each grid corresponds to a different simulation setting of K (number of causal variants) and W (enrichment intensity). Error bars represent 95% confidence intervals for enrichment estimates. Blue dots are estimated values and yellow triangles are simulated values.</a:t>
            </a:r>
          </a:p>
        </p:txBody>
      </p:sp>
    </p:spTree>
    <p:extLst>
      <p:ext uri="{BB962C8B-B14F-4D97-AF65-F5344CB8AC3E}">
        <p14:creationId xmlns:p14="http://schemas.microsoft.com/office/powerpoint/2010/main" val="344906968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a14="http://schemas.microsoft.com/office/drawing/2010/main">
        <mc:Choice Requires="a14"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34686590-379F-744D-E27C-7ABA0E9E08A9}"/>
                  </a:ext>
                </a:extLst>
              </p:cNvPr>
              <p:cNvSpPr txBox="1"/>
              <p:nvPr/>
            </p:nvSpPr>
            <p:spPr>
              <a:xfrm>
                <a:off x="0" y="7998863"/>
                <a:ext cx="7558208" cy="175432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just"/>
                <a:r>
                  <a:rPr lang="en-US" dirty="0"/>
                  <a:t>Supplementary Figure S10: (A) GWAS summary statistics for pulse rate at the GCKR locus. (B) Fine-mapping results from </a:t>
                </a:r>
                <a:r>
                  <a:rPr lang="en-US" dirty="0" err="1"/>
                  <a:t>SparsePro</a:t>
                </a:r>
                <a:r>
                  <a:rPr lang="en-US" dirty="0"/>
                  <a:t>-. (C) Fine-mapping results from </a:t>
                </a:r>
                <a:r>
                  <a:rPr lang="en-US" dirty="0" err="1"/>
                  <a:t>SparsePro</a:t>
                </a:r>
                <a:r>
                  <a:rPr lang="en-US" dirty="0"/>
                  <a:t>+. (D) Fine-mapping results from </a:t>
                </a:r>
                <a:r>
                  <a:rPr lang="en-US" dirty="0" err="1"/>
                  <a:t>SparsePro+PolyFun</a:t>
                </a:r>
                <a:r>
                  <a:rPr lang="en-US" dirty="0"/>
                  <a:t>. P-values from GWASs and inferred posterior inclusion probabilities from fine-mapping are illustrated. Variants within a </a:t>
                </a:r>
                <a14:m>
                  <m:oMath xmlns:m="http://schemas.openxmlformats.org/officeDocument/2006/math">
                    <m:r>
                      <a:rPr lang="en-CA" b="0" i="1" smtClean="0">
                        <a:latin typeface="Cambria Math" panose="02040503050406030204" pitchFamily="18" charset="0"/>
                      </a:rPr>
                      <m:t>±</m:t>
                    </m:r>
                  </m:oMath>
                </a14:m>
                <a:r>
                  <a:rPr lang="en-US" dirty="0"/>
                  <a:t>500kb window are colored by their linkage disequilibrium r</a:t>
                </a:r>
                <a:r>
                  <a:rPr lang="en-US" baseline="30000" dirty="0"/>
                  <a:t>2</a:t>
                </a:r>
                <a:r>
                  <a:rPr lang="en-US" dirty="0"/>
                  <a:t> with rs1260326. </a:t>
                </a:r>
              </a:p>
            </p:txBody>
          </p:sp>
        </mc:Choice>
        <mc:Fallback xmlns=""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34686590-379F-744D-E27C-7ABA0E9E08A9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0" y="7998863"/>
                <a:ext cx="7558208" cy="1754326"/>
              </a:xfrm>
              <a:prstGeom prst="rect">
                <a:avLst/>
              </a:prstGeom>
              <a:blipFill>
                <a:blip r:embed="rId3"/>
                <a:stretch>
                  <a:fillRect l="-671" t="-1439" r="-671" b="-5036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grpSp>
        <p:nvGrpSpPr>
          <p:cNvPr id="11" name="Group 10">
            <a:extLst>
              <a:ext uri="{FF2B5EF4-FFF2-40B4-BE49-F238E27FC236}">
                <a16:creationId xmlns:a16="http://schemas.microsoft.com/office/drawing/2014/main" id="{A326B7A1-8731-0B78-910F-EA8C0F275BD6}"/>
              </a:ext>
            </a:extLst>
          </p:cNvPr>
          <p:cNvGrpSpPr/>
          <p:nvPr/>
        </p:nvGrpSpPr>
        <p:grpSpPr>
          <a:xfrm>
            <a:off x="12749" y="948225"/>
            <a:ext cx="6100185" cy="7050638"/>
            <a:chOff x="12749" y="948225"/>
            <a:chExt cx="6100185" cy="7050638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08823E24-60C5-AE44-5C0B-D32A4A29B103}"/>
                </a:ext>
              </a:extLst>
            </p:cNvPr>
            <p:cNvGrpSpPr/>
            <p:nvPr/>
          </p:nvGrpSpPr>
          <p:grpSpPr>
            <a:xfrm>
              <a:off x="159135" y="1043339"/>
              <a:ext cx="5953799" cy="6955524"/>
              <a:chOff x="159135" y="440667"/>
              <a:chExt cx="5953799" cy="6955524"/>
            </a:xfrm>
          </p:grpSpPr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17AA45A3-F431-854F-1477-D8864E73929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r="26587"/>
              <a:stretch/>
            </p:blipFill>
            <p:spPr>
              <a:xfrm>
                <a:off x="159135" y="440667"/>
                <a:ext cx="2997006" cy="3402000"/>
              </a:xfrm>
              <a:prstGeom prst="rect">
                <a:avLst/>
              </a:prstGeom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390DF237-5F32-9F0C-509A-0E3BB0CC9B3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r="26587"/>
              <a:stretch/>
            </p:blipFill>
            <p:spPr>
              <a:xfrm>
                <a:off x="159135" y="3994191"/>
                <a:ext cx="2997006" cy="3402000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C7714A7C-F101-5E04-440A-F414EFCF1CA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r="26569"/>
              <a:stretch/>
            </p:blipFill>
            <p:spPr>
              <a:xfrm>
                <a:off x="3115928" y="441490"/>
                <a:ext cx="2997006" cy="3401177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C5A1A65A-AE83-79F6-5EC6-30877BAF54A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r="26569"/>
              <a:stretch/>
            </p:blipFill>
            <p:spPr>
              <a:xfrm>
                <a:off x="3115926" y="3995014"/>
                <a:ext cx="2997007" cy="3401177"/>
              </a:xfrm>
              <a:prstGeom prst="rect">
                <a:avLst/>
              </a:prstGeom>
            </p:spPr>
          </p:pic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9460DE18-0A88-0589-14D1-D9128EDB2FB2}"/>
                </a:ext>
              </a:extLst>
            </p:cNvPr>
            <p:cNvSpPr txBox="1"/>
            <p:nvPr/>
          </p:nvSpPr>
          <p:spPr>
            <a:xfrm>
              <a:off x="12749" y="948225"/>
              <a:ext cx="30328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A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A74A3392-2DFA-2DC4-44B5-C3A9794A5781}"/>
                </a:ext>
              </a:extLst>
            </p:cNvPr>
            <p:cNvSpPr txBox="1"/>
            <p:nvPr/>
          </p:nvSpPr>
          <p:spPr>
            <a:xfrm>
              <a:off x="3074568" y="948225"/>
              <a:ext cx="29687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B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D04F33C-9953-9DF5-4E08-659C21371391}"/>
                </a:ext>
              </a:extLst>
            </p:cNvPr>
            <p:cNvSpPr txBox="1"/>
            <p:nvPr/>
          </p:nvSpPr>
          <p:spPr>
            <a:xfrm>
              <a:off x="3074568" y="4494821"/>
              <a:ext cx="31130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D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26AFAE0-267B-9509-8F83-5D76C6AE8BCC}"/>
                </a:ext>
              </a:extLst>
            </p:cNvPr>
            <p:cNvSpPr txBox="1"/>
            <p:nvPr/>
          </p:nvSpPr>
          <p:spPr>
            <a:xfrm>
              <a:off x="12749" y="4494821"/>
              <a:ext cx="29367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C</a:t>
              </a:r>
            </a:p>
          </p:txBody>
        </p:sp>
      </p:grpSp>
      <p:pic>
        <p:nvPicPr>
          <p:cNvPr id="14" name="Picture 13">
            <a:extLst>
              <a:ext uri="{FF2B5EF4-FFF2-40B4-BE49-F238E27FC236}">
                <a16:creationId xmlns:a16="http://schemas.microsoft.com/office/drawing/2014/main" id="{59CA49AE-58E5-A3A5-345D-9D7161F46889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5801" t="31676" r="356" b="60267"/>
          <a:stretch/>
        </p:blipFill>
        <p:spPr>
          <a:xfrm>
            <a:off x="5705763" y="5206740"/>
            <a:ext cx="1853912" cy="523221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93DF26FB-0CE5-D9D8-38F4-0435F30F1FFD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5801" t="44543" r="14124" b="24460"/>
          <a:stretch/>
        </p:blipFill>
        <p:spPr>
          <a:xfrm>
            <a:off x="6510100" y="5850678"/>
            <a:ext cx="650940" cy="17165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9423171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, diagram, line, plot&#10;&#10;Description automatically generated">
            <a:extLst>
              <a:ext uri="{FF2B5EF4-FFF2-40B4-BE49-F238E27FC236}">
                <a16:creationId xmlns:a16="http://schemas.microsoft.com/office/drawing/2014/main" id="{D68D12A5-463E-E498-C4E8-FC1F01432B2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187" y="1101436"/>
            <a:ext cx="7353300" cy="71755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44408FE-3A89-78D5-A64E-742C08934239}"/>
              </a:ext>
            </a:extLst>
          </p:cNvPr>
          <p:cNvSpPr txBox="1"/>
          <p:nvPr/>
        </p:nvSpPr>
        <p:spPr>
          <a:xfrm>
            <a:off x="0" y="8276936"/>
            <a:ext cx="7558208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defTabSz="914400">
              <a:defRPr/>
            </a:pPr>
            <a:r>
              <a:rPr lang="en-US" dirty="0"/>
              <a:t>Supplementary Figure S11: Comparison of posterior inclusion probabilities (PIP) in the simulation setting of K (number of causal variants) = 5 and W (enrichment intensity) = 2 between </a:t>
            </a:r>
            <a:r>
              <a:rPr lang="en-US" dirty="0" err="1"/>
              <a:t>SuSiE</a:t>
            </a:r>
            <a:r>
              <a:rPr lang="en-US" dirty="0"/>
              <a:t> and </a:t>
            </a:r>
            <a:r>
              <a:rPr lang="en-US" dirty="0" err="1"/>
              <a:t>SuSiE</a:t>
            </a:r>
            <a:r>
              <a:rPr lang="en-US" dirty="0"/>
              <a:t> with hyperparameters estimated from HESS (</a:t>
            </a:r>
            <a:r>
              <a:rPr lang="en-US" dirty="0" err="1"/>
              <a:t>SuSiE+HESS</a:t>
            </a:r>
            <a:r>
              <a:rPr lang="en-US" dirty="0"/>
              <a:t>). True causal variants are colored red and non-causal variants are colored black. </a:t>
            </a:r>
          </a:p>
          <a:p>
            <a:pPr algn="just" defTabSz="914400">
              <a:defRPr/>
            </a:pP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417042668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, plot, line, diagram&#10;&#10;Description automatically generated">
            <a:extLst>
              <a:ext uri="{FF2B5EF4-FFF2-40B4-BE49-F238E27FC236}">
                <a16:creationId xmlns:a16="http://schemas.microsoft.com/office/drawing/2014/main" id="{F31E55DD-8357-0B27-3F0D-321DA15A7E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187" y="1059874"/>
            <a:ext cx="7353300" cy="71755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49B3CFD-3AE3-13DC-5C2E-C8FB1CBA92B0}"/>
              </a:ext>
            </a:extLst>
          </p:cNvPr>
          <p:cNvSpPr txBox="1"/>
          <p:nvPr/>
        </p:nvSpPr>
        <p:spPr>
          <a:xfrm>
            <a:off x="1467" y="8235374"/>
            <a:ext cx="7558208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defTabSz="914400">
              <a:defRPr/>
            </a:pPr>
            <a:r>
              <a:rPr lang="en-US" dirty="0"/>
              <a:t>Supplementary Figure S12: Comparison of posterior inclusion probabilities (PIP) in the simulation setting of K (number of causal variants) = 5 and W (enrichment intensity) = 2 between </a:t>
            </a:r>
            <a:r>
              <a:rPr lang="en-US" dirty="0" err="1"/>
              <a:t>SparsePro</a:t>
            </a:r>
            <a:r>
              <a:rPr lang="en-US" dirty="0"/>
              <a:t>- (</a:t>
            </a:r>
            <a:r>
              <a:rPr lang="en-US" dirty="0" err="1"/>
              <a:t>SparsePro</a:t>
            </a:r>
            <a:r>
              <a:rPr lang="en-US" dirty="0"/>
              <a:t> without functional annotations) and </a:t>
            </a:r>
            <a:r>
              <a:rPr lang="en-US" dirty="0" err="1"/>
              <a:t>SuSiE</a:t>
            </a:r>
            <a:r>
              <a:rPr lang="en-US" dirty="0"/>
              <a:t> with hyperparameters estimated from HESS (</a:t>
            </a:r>
            <a:r>
              <a:rPr lang="en-US" dirty="0" err="1"/>
              <a:t>SuSiE+HESS</a:t>
            </a:r>
            <a:r>
              <a:rPr lang="en-US" dirty="0"/>
              <a:t>). True causal variants are colored red and non-causal variants are colored black. </a:t>
            </a:r>
          </a:p>
          <a:p>
            <a:pPr algn="just" defTabSz="914400">
              <a:defRPr/>
            </a:pP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60477093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plot, line, diagram&#10;&#10;Description automatically generated">
            <a:extLst>
              <a:ext uri="{FF2B5EF4-FFF2-40B4-BE49-F238E27FC236}">
                <a16:creationId xmlns:a16="http://schemas.microsoft.com/office/drawing/2014/main" id="{1201C870-38E5-6602-0B00-2ABCBDC8D56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720" y="1163782"/>
            <a:ext cx="7353300" cy="71755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4CAFF16-5CE8-EB75-7BA7-DF9BD938B073}"/>
              </a:ext>
            </a:extLst>
          </p:cNvPr>
          <p:cNvSpPr txBox="1"/>
          <p:nvPr/>
        </p:nvSpPr>
        <p:spPr>
          <a:xfrm>
            <a:off x="0" y="8339282"/>
            <a:ext cx="7558208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defTabSz="914400">
              <a:defRPr/>
            </a:pPr>
            <a:r>
              <a:rPr lang="en-US" dirty="0"/>
              <a:t>Supplementary Figure S13: Comparison of posterior inclusion probabilities (PIP) in the simulation setting of K (number of causal variants) = 5 and W (enrichment intensity) = 2 between </a:t>
            </a:r>
            <a:r>
              <a:rPr lang="en-US" dirty="0" err="1"/>
              <a:t>SuSiE</a:t>
            </a:r>
            <a:r>
              <a:rPr lang="en-US" dirty="0"/>
              <a:t> with hyperparameters estimated from HESS (</a:t>
            </a:r>
            <a:r>
              <a:rPr lang="en-US" dirty="0" err="1"/>
              <a:t>SuSiE+HESS</a:t>
            </a:r>
            <a:r>
              <a:rPr lang="en-US" dirty="0"/>
              <a:t>) and </a:t>
            </a:r>
            <a:r>
              <a:rPr lang="en-US" dirty="0" err="1"/>
              <a:t>SuSiE</a:t>
            </a:r>
            <a:r>
              <a:rPr lang="en-US" dirty="0"/>
              <a:t> with hyperparameters estimated from HESS  and posterior summaries proposed in </a:t>
            </a:r>
            <a:r>
              <a:rPr lang="en-US" dirty="0" err="1"/>
              <a:t>SparsePro</a:t>
            </a:r>
            <a:r>
              <a:rPr lang="en-US" dirty="0"/>
              <a:t> (</a:t>
            </a:r>
            <a:r>
              <a:rPr lang="en-US" dirty="0" err="1"/>
              <a:t>SuSiE+SparsePro</a:t>
            </a:r>
            <a:r>
              <a:rPr lang="en-US" dirty="0"/>
              <a:t>). True causal variants are colored red and non-causal variants are colored black. </a:t>
            </a:r>
          </a:p>
          <a:p>
            <a:pPr algn="just" defTabSz="914400">
              <a:defRPr/>
            </a:pP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557765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6EF26D5-E68D-D405-698A-7D6749E222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7559675" cy="907161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9D8F5AA-D63D-1E8A-1AF7-D0021AEFABE1}"/>
              </a:ext>
            </a:extLst>
          </p:cNvPr>
          <p:cNvSpPr txBox="1"/>
          <p:nvPr/>
        </p:nvSpPr>
        <p:spPr>
          <a:xfrm>
            <a:off x="-1" y="8985152"/>
            <a:ext cx="7559675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 defTabSz="914400">
              <a:defRPr/>
            </a:pPr>
            <a:r>
              <a:rPr lang="en-US" dirty="0"/>
              <a:t>Supplementary Figure S2: Annotation enrichment weights estimated by PAINTOR in locus simulations. Each grid corresponds to a different simulation setting of K (number of causal variants) and W (enrichment intensity). PAINTOR does not provide confidence intervals for enrichment weights. Blue dots are estimated values and yellow triangles are simulated values.</a:t>
            </a:r>
          </a:p>
        </p:txBody>
      </p:sp>
    </p:spTree>
    <p:extLst>
      <p:ext uri="{BB962C8B-B14F-4D97-AF65-F5344CB8AC3E}">
        <p14:creationId xmlns:p14="http://schemas.microsoft.com/office/powerpoint/2010/main" val="1998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6E3B31C-8966-D07B-F241-D24BD25451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7559675" cy="907161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AE12302-0322-8BA6-4D0C-E7A3F7456295}"/>
              </a:ext>
            </a:extLst>
          </p:cNvPr>
          <p:cNvSpPr txBox="1"/>
          <p:nvPr/>
        </p:nvSpPr>
        <p:spPr>
          <a:xfrm>
            <a:off x="0" y="9023959"/>
            <a:ext cx="7558208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 defTabSz="914400">
              <a:defRPr/>
            </a:pPr>
            <a:r>
              <a:rPr lang="en-US" dirty="0"/>
              <a:t>Supplementary Figure S3: Annotation enrichment weights estimated by </a:t>
            </a:r>
            <a:r>
              <a:rPr lang="en-US" dirty="0" err="1"/>
              <a:t>SparsePro</a:t>
            </a:r>
            <a:r>
              <a:rPr lang="en-US" dirty="0"/>
              <a:t> in genome-wide simulations. Each row represents a different simulation setting with W (enrichment intensity) = 0, 1, or 2. Error bars represent 95% confidence intervals for enrichment estimates. Blue dots are estimated values and yellow triangles are simulated values.</a:t>
            </a:r>
          </a:p>
          <a:p>
            <a:pPr algn="just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545896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C3B2A04-1F71-925C-8842-A50218D54EA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0"/>
            <a:ext cx="7559675" cy="907161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6F5E290-457A-99BB-CAC5-D110B55DFBCF}"/>
              </a:ext>
            </a:extLst>
          </p:cNvPr>
          <p:cNvSpPr txBox="1"/>
          <p:nvPr/>
        </p:nvSpPr>
        <p:spPr>
          <a:xfrm>
            <a:off x="1467" y="8950587"/>
            <a:ext cx="7558208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 defTabSz="914400">
              <a:defRPr/>
            </a:pPr>
            <a:r>
              <a:rPr lang="en-US" dirty="0"/>
              <a:t>Supplementary Figure S4: Enrichment weights estimated jointly by </a:t>
            </a:r>
            <a:r>
              <a:rPr lang="en-US" dirty="0" err="1"/>
              <a:t>SparsePro</a:t>
            </a:r>
            <a:r>
              <a:rPr lang="en-US" dirty="0"/>
              <a:t> without filtering annotations in genome-wide simulations. Each row represents a different simulation setting with W (enrichment intensity) = 0, 1, or 2. Error bars represent 95% confidence intervals for enrichment estimates. Blue dots are estimated values and yellow dots are simulated values.</a:t>
            </a:r>
          </a:p>
          <a:p>
            <a:pPr algn="just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341750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BADCB8B5-3322-E442-D30E-D8B9ED7CA3DC}"/>
              </a:ext>
            </a:extLst>
          </p:cNvPr>
          <p:cNvSpPr txBox="1"/>
          <p:nvPr/>
        </p:nvSpPr>
        <p:spPr>
          <a:xfrm>
            <a:off x="1467" y="8686536"/>
            <a:ext cx="7558208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defTabSz="914400">
              <a:defRPr/>
            </a:pPr>
            <a:r>
              <a:rPr lang="en-US" dirty="0"/>
              <a:t>Supplementary Figure S5: Comparison of posterior inclusion probabilities (PIP) obtained using different methods in the simulation setting of W (enrichment intensity) = 1. True causal variants are colored red and non-causal variants are colored black. </a:t>
            </a:r>
          </a:p>
          <a:p>
            <a:pPr algn="just" defTabSz="914400">
              <a:defRPr/>
            </a:pPr>
            <a:r>
              <a:rPr lang="en-US" dirty="0"/>
              <a:t> 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47DCC1A5-6E43-0267-3391-FEF94EBDF0EE}"/>
              </a:ext>
            </a:extLst>
          </p:cNvPr>
          <p:cNvGrpSpPr/>
          <p:nvPr/>
        </p:nvGrpSpPr>
        <p:grpSpPr>
          <a:xfrm>
            <a:off x="1467" y="1080655"/>
            <a:ext cx="7559675" cy="7605881"/>
            <a:chOff x="-1" y="0"/>
            <a:chExt cx="7559675" cy="7605881"/>
          </a:xfrm>
        </p:grpSpPr>
        <p:pic>
          <p:nvPicPr>
            <p:cNvPr id="7" name="Picture 6" descr="A picture containing text, screenshot&#10;&#10;Description automatically generated">
              <a:extLst>
                <a:ext uri="{FF2B5EF4-FFF2-40B4-BE49-F238E27FC236}">
                  <a16:creationId xmlns:a16="http://schemas.microsoft.com/office/drawing/2014/main" id="{56792AFD-BFD8-D86A-58F7-2BD172833D5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-1" y="0"/>
              <a:ext cx="7559675" cy="7305347"/>
            </a:xfrm>
            <a:prstGeom prst="rect">
              <a:avLst/>
            </a:prstGeom>
          </p:spPr>
        </p:pic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F776CBD5-DB52-C2D2-CECE-EB4932E0C8C8}"/>
                </a:ext>
              </a:extLst>
            </p:cNvPr>
            <p:cNvGrpSpPr/>
            <p:nvPr/>
          </p:nvGrpSpPr>
          <p:grpSpPr>
            <a:xfrm>
              <a:off x="5876218" y="7298104"/>
              <a:ext cx="1681989" cy="307777"/>
              <a:chOff x="5872036" y="4887053"/>
              <a:chExt cx="1681989" cy="307777"/>
            </a:xfrm>
          </p:grpSpPr>
          <p:sp>
            <p:nvSpPr>
              <p:cNvPr id="3" name="Oval 2">
                <a:extLst>
                  <a:ext uri="{FF2B5EF4-FFF2-40B4-BE49-F238E27FC236}">
                    <a16:creationId xmlns:a16="http://schemas.microsoft.com/office/drawing/2014/main" id="{F145CA72-934B-0380-B0A9-F5F7C78B6052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6566572" y="5028559"/>
                <a:ext cx="47791" cy="45719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" name="Oval 3">
                <a:extLst>
                  <a:ext uri="{FF2B5EF4-FFF2-40B4-BE49-F238E27FC236}">
                    <a16:creationId xmlns:a16="http://schemas.microsoft.com/office/drawing/2014/main" id="{1DB8366C-C7F1-C1D8-5D5F-370FB2C9FBBC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882100" y="5028559"/>
                <a:ext cx="47791" cy="45719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F7266558-C01E-2BEE-3840-19D963E6B242}"/>
                  </a:ext>
                </a:extLst>
              </p:cNvPr>
              <p:cNvSpPr txBox="1"/>
              <p:nvPr/>
            </p:nvSpPr>
            <p:spPr>
              <a:xfrm>
                <a:off x="5872036" y="4887053"/>
                <a:ext cx="66075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solidFill>
                      <a:srgbClr val="FF0000"/>
                    </a:solidFill>
                  </a:rPr>
                  <a:t>Causal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F9E3666A-9326-032B-842C-AC8AE77CAEBB}"/>
                  </a:ext>
                </a:extLst>
              </p:cNvPr>
              <p:cNvSpPr txBox="1"/>
              <p:nvPr/>
            </p:nvSpPr>
            <p:spPr>
              <a:xfrm>
                <a:off x="6556508" y="4887053"/>
                <a:ext cx="99751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Non-causal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0261822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7FA58EC-3190-EC20-AFFC-41CDBB3B20DD}"/>
              </a:ext>
            </a:extLst>
          </p:cNvPr>
          <p:cNvSpPr txBox="1"/>
          <p:nvPr/>
        </p:nvSpPr>
        <p:spPr>
          <a:xfrm>
            <a:off x="1467" y="8686534"/>
            <a:ext cx="7558208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defTabSz="914400">
              <a:defRPr/>
            </a:pPr>
            <a:r>
              <a:rPr lang="en-US" dirty="0"/>
              <a:t>Supplementary Figure S6: Comparison of posterior inclusion probabilities (PIP) obtained using different methods in the simulation setting of W (enrichment intensity) = 0. True causal variants are colored red and non-causal variants are colored black. </a:t>
            </a:r>
          </a:p>
          <a:p>
            <a:pPr algn="just" defTabSz="914400">
              <a:defRPr/>
            </a:pPr>
            <a:r>
              <a:rPr lang="en-US" dirty="0"/>
              <a:t> 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4D7B554C-395C-318B-3EF5-AA4B69EB9029}"/>
              </a:ext>
            </a:extLst>
          </p:cNvPr>
          <p:cNvGrpSpPr/>
          <p:nvPr/>
        </p:nvGrpSpPr>
        <p:grpSpPr>
          <a:xfrm>
            <a:off x="1468" y="1080653"/>
            <a:ext cx="7559675" cy="7605881"/>
            <a:chOff x="0" y="0"/>
            <a:chExt cx="7559675" cy="7605881"/>
          </a:xfrm>
        </p:grpSpPr>
        <p:pic>
          <p:nvPicPr>
            <p:cNvPr id="3" name="Picture 2" descr="A picture containing text, diagram, plot, line&#10;&#10;Description automatically generated">
              <a:extLst>
                <a:ext uri="{FF2B5EF4-FFF2-40B4-BE49-F238E27FC236}">
                  <a16:creationId xmlns:a16="http://schemas.microsoft.com/office/drawing/2014/main" id="{9707A398-2736-525C-A802-A46981B404E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0"/>
              <a:ext cx="7559675" cy="7305347"/>
            </a:xfrm>
            <a:prstGeom prst="rect">
              <a:avLst/>
            </a:prstGeom>
          </p:spPr>
        </p:pic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6B4ED038-5CC3-1012-11C3-E9C8BB00FAFA}"/>
                </a:ext>
              </a:extLst>
            </p:cNvPr>
            <p:cNvGrpSpPr/>
            <p:nvPr/>
          </p:nvGrpSpPr>
          <p:grpSpPr>
            <a:xfrm>
              <a:off x="5876218" y="7298104"/>
              <a:ext cx="1681989" cy="307777"/>
              <a:chOff x="5872036" y="4887053"/>
              <a:chExt cx="1681989" cy="307777"/>
            </a:xfrm>
          </p:grpSpPr>
          <p:sp>
            <p:nvSpPr>
              <p:cNvPr id="12" name="Oval 11">
                <a:extLst>
                  <a:ext uri="{FF2B5EF4-FFF2-40B4-BE49-F238E27FC236}">
                    <a16:creationId xmlns:a16="http://schemas.microsoft.com/office/drawing/2014/main" id="{94E2D91A-E493-73C5-5704-A3DBFB74550A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6566572" y="5028559"/>
                <a:ext cx="47791" cy="45719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" name="Oval 12">
                <a:extLst>
                  <a:ext uri="{FF2B5EF4-FFF2-40B4-BE49-F238E27FC236}">
                    <a16:creationId xmlns:a16="http://schemas.microsoft.com/office/drawing/2014/main" id="{F56EE0CD-A6DF-3A0A-D6A6-4E450347E8C2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882100" y="5028559"/>
                <a:ext cx="47791" cy="45719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0A7C4C68-469B-E3B9-ED24-C0258E1CF3F3}"/>
                  </a:ext>
                </a:extLst>
              </p:cNvPr>
              <p:cNvSpPr txBox="1"/>
              <p:nvPr/>
            </p:nvSpPr>
            <p:spPr>
              <a:xfrm>
                <a:off x="5872036" y="4887053"/>
                <a:ext cx="66075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solidFill>
                      <a:srgbClr val="FF0000"/>
                    </a:solidFill>
                  </a:rPr>
                  <a:t>Causal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DB4EE5F3-76D7-B3BC-FC8A-9A2CE69379DD}"/>
                  </a:ext>
                </a:extLst>
              </p:cNvPr>
              <p:cNvSpPr txBox="1"/>
              <p:nvPr/>
            </p:nvSpPr>
            <p:spPr>
              <a:xfrm>
                <a:off x="6556508" y="4887053"/>
                <a:ext cx="99751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Non-causal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6088143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59ACA0B-972C-408B-88DF-29C78968C1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4480"/>
            <a:ext cx="7559675" cy="907161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990C0DC-0526-E2B9-44AF-13ED56E3B789}"/>
              </a:ext>
            </a:extLst>
          </p:cNvPr>
          <p:cNvSpPr txBox="1"/>
          <p:nvPr/>
        </p:nvSpPr>
        <p:spPr>
          <a:xfrm>
            <a:off x="1467" y="9214485"/>
            <a:ext cx="7558208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dirty="0"/>
              <a:t>Supplementary Figure S7: Enrichment fold of annotations in fine-mapping functional biomarkers. Each row denotes an annotation and each column denotes a functional biomarker. Error bars represent 95% confidence intervals for enrichment estimates.</a:t>
            </a:r>
          </a:p>
          <a:p>
            <a:pPr algn="just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6417971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974C11C-2D07-924A-D53F-3BE1F260B2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504" y="1267691"/>
            <a:ext cx="7315200" cy="71374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3109B70-85AC-DD72-5DB1-89AA9669E8FB}"/>
              </a:ext>
            </a:extLst>
          </p:cNvPr>
          <p:cNvSpPr txBox="1"/>
          <p:nvPr/>
        </p:nvSpPr>
        <p:spPr>
          <a:xfrm>
            <a:off x="0" y="8405091"/>
            <a:ext cx="7558208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dirty="0"/>
              <a:t>Supplementary Figure S8: Calibration curves for </a:t>
            </a:r>
            <a:r>
              <a:rPr lang="en-US" dirty="0" err="1"/>
              <a:t>SuSiE</a:t>
            </a:r>
            <a:r>
              <a:rPr lang="en-US" dirty="0"/>
              <a:t> and </a:t>
            </a:r>
            <a:r>
              <a:rPr lang="en-US" dirty="0" err="1"/>
              <a:t>SuSiE</a:t>
            </a:r>
            <a:r>
              <a:rPr lang="en-US" dirty="0"/>
              <a:t> with hyperparameters estimated from HESS. Variants are grouped into five bins according to their PIP values. Each dot represents one bin. The actual precision (y-axis) is plotted against the expected precision (x-axis) calculated by mean PIP values across all variants in the bin.</a:t>
            </a:r>
          </a:p>
        </p:txBody>
      </p:sp>
    </p:spTree>
    <p:extLst>
      <p:ext uri="{BB962C8B-B14F-4D97-AF65-F5344CB8AC3E}">
        <p14:creationId xmlns:p14="http://schemas.microsoft.com/office/powerpoint/2010/main" val="327722549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31915C7D-9FB1-0985-6511-7F60A28A437D}"/>
              </a:ext>
            </a:extLst>
          </p:cNvPr>
          <p:cNvGrpSpPr/>
          <p:nvPr/>
        </p:nvGrpSpPr>
        <p:grpSpPr>
          <a:xfrm>
            <a:off x="0" y="1857651"/>
            <a:ext cx="7561142" cy="5589547"/>
            <a:chOff x="-1468" y="132760"/>
            <a:chExt cx="7561142" cy="5589547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A863E1B3-CCE4-9DBE-C65F-3D08A32E597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r="19790"/>
            <a:stretch/>
          </p:blipFill>
          <p:spPr>
            <a:xfrm>
              <a:off x="-1468" y="132760"/>
              <a:ext cx="6063601" cy="1813123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9E86BB38-422E-B083-2A7B-FB32326DA3E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-1" y="2054422"/>
              <a:ext cx="7559675" cy="179006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2F4D2684-51BC-67B0-0046-719C7C9F4A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r="19810"/>
            <a:stretch/>
          </p:blipFill>
          <p:spPr>
            <a:xfrm>
              <a:off x="0" y="3953021"/>
              <a:ext cx="6062134" cy="1769286"/>
            </a:xfrm>
            <a:prstGeom prst="rect">
              <a:avLst/>
            </a:prstGeom>
          </p:spPr>
        </p:pic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EAC23B2C-51F3-4780-7031-99FBAD246AEB}"/>
              </a:ext>
            </a:extLst>
          </p:cNvPr>
          <p:cNvSpPr txBox="1"/>
          <p:nvPr/>
        </p:nvSpPr>
        <p:spPr>
          <a:xfrm>
            <a:off x="1467" y="7555737"/>
            <a:ext cx="7558208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dirty="0"/>
              <a:t>Supplementary Figure S9: Summary of coverage, power and size of 95% credible sets in different simulation settings for </a:t>
            </a:r>
            <a:r>
              <a:rPr lang="en-US" dirty="0" err="1"/>
              <a:t>SuSiE</a:t>
            </a:r>
            <a:r>
              <a:rPr lang="en-US" dirty="0"/>
              <a:t>, </a:t>
            </a:r>
            <a:r>
              <a:rPr lang="en-US" dirty="0" err="1"/>
              <a:t>SuSiE</a:t>
            </a:r>
            <a:r>
              <a:rPr lang="en-US" dirty="0"/>
              <a:t> with hyperparameters estimated from HESS (</a:t>
            </a:r>
            <a:r>
              <a:rPr lang="en-US" dirty="0" err="1"/>
              <a:t>SuSiE+HESS</a:t>
            </a:r>
            <a:r>
              <a:rPr lang="en-US" dirty="0"/>
              <a:t>) and </a:t>
            </a:r>
            <a:r>
              <a:rPr lang="en-US" dirty="0" err="1"/>
              <a:t>SuSiE</a:t>
            </a:r>
            <a:r>
              <a:rPr lang="en-US" dirty="0"/>
              <a:t> with hyperparameters estimated from HESS  and posterior summaries proposed in </a:t>
            </a:r>
            <a:r>
              <a:rPr lang="en-US" dirty="0" err="1"/>
              <a:t>SparsePro</a:t>
            </a:r>
            <a:r>
              <a:rPr lang="en-US" dirty="0"/>
              <a:t> (</a:t>
            </a:r>
            <a:r>
              <a:rPr lang="en-US" dirty="0" err="1"/>
              <a:t>SuSiE+SparsePro</a:t>
            </a:r>
            <a:r>
              <a:rPr lang="en-US" dirty="0"/>
              <a:t>). </a:t>
            </a:r>
          </a:p>
        </p:txBody>
      </p:sp>
    </p:spTree>
    <p:extLst>
      <p:ext uri="{BB962C8B-B14F-4D97-AF65-F5344CB8AC3E}">
        <p14:creationId xmlns:p14="http://schemas.microsoft.com/office/powerpoint/2010/main" val="35278557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09</TotalTime>
  <Words>764</Words>
  <Application>Microsoft Macintosh PowerPoint</Application>
  <PresentationFormat>Custom</PresentationFormat>
  <Paragraphs>29</Paragraphs>
  <Slides>1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8" baseType="lpstr">
      <vt:lpstr>Arial</vt:lpstr>
      <vt:lpstr>Calibri</vt:lpstr>
      <vt:lpstr>Calibri Light</vt:lpstr>
      <vt:lpstr>Cambria Math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anyuan Lu</dc:creator>
  <cp:lastModifiedBy>Wenmin Zhang</cp:lastModifiedBy>
  <cp:revision>68</cp:revision>
  <dcterms:created xsi:type="dcterms:W3CDTF">2022-08-14T19:51:27Z</dcterms:created>
  <dcterms:modified xsi:type="dcterms:W3CDTF">2023-06-28T20:02:40Z</dcterms:modified>
</cp:coreProperties>
</file>